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90" r:id="rId2"/>
    <p:sldId id="285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DA7424-F72B-1EB5-697F-CA9333E57F0A}" name="PhilR" initials="PJR" userId="PhilR" providerId="None"/>
  <p188:author id="{3B063878-6895-4B8D-823B-C7D9104357F1}" name="Roger Reddel" initials="RR" userId="S::rreddel@cmri.org.au::750bfe6e-02cc-4cce-a1ed-bde13e6cbbb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13" autoAdjust="0"/>
    <p:restoredTop sz="95748" autoAdjust="0"/>
  </p:normalViewPr>
  <p:slideViewPr>
    <p:cSldViewPr snapToGrid="0">
      <p:cViewPr varScale="1">
        <p:scale>
          <a:sx n="69" d="100"/>
          <a:sy n="69" d="100"/>
        </p:scale>
        <p:origin x="230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BFE566-B291-6C40-A8EB-8EA7FEA7A444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0A3A11-C076-CF4F-B186-F8DBC4F2A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79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9312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0091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660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3282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4586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53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112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618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182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1319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9719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5162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6BF909DA-3F0F-2EF8-81D8-69B77D86B8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3161" y="1197196"/>
            <a:ext cx="5170063" cy="358617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54DEC84-3F61-395B-848C-199FD1C1AD75}"/>
              </a:ext>
            </a:extLst>
          </p:cNvPr>
          <p:cNvSpPr txBox="1"/>
          <p:nvPr/>
        </p:nvSpPr>
        <p:spPr>
          <a:xfrm>
            <a:off x="233697" y="709779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5A6FE44-9D99-2020-CD59-E866556B830F}"/>
              </a:ext>
            </a:extLst>
          </p:cNvPr>
          <p:cNvSpPr txBox="1"/>
          <p:nvPr/>
        </p:nvSpPr>
        <p:spPr>
          <a:xfrm>
            <a:off x="616166" y="783482"/>
            <a:ext cx="5828927" cy="560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AU" sz="16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ultivariate cox model applied on risk score and clinical variables</a:t>
            </a:r>
            <a:r>
              <a:rPr lang="en-AU" sz="16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B77ECB-B5EF-829C-7D6D-1A5C20EEEA8F}"/>
              </a:ext>
            </a:extLst>
          </p:cNvPr>
          <p:cNvSpPr txBox="1"/>
          <p:nvPr/>
        </p:nvSpPr>
        <p:spPr>
          <a:xfrm>
            <a:off x="203206" y="4960934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B502D48-7F1B-5F87-CF36-AD7F482E9191}"/>
              </a:ext>
            </a:extLst>
          </p:cNvPr>
          <p:cNvSpPr txBox="1"/>
          <p:nvPr/>
        </p:nvSpPr>
        <p:spPr>
          <a:xfrm>
            <a:off x="616167" y="5034031"/>
            <a:ext cx="6034084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6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ultivariate cox model applied on risk score and clinical variables using adjusted recurrence patient population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8C7740C-62F9-2581-B80F-21EFD1652B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8674" y="5618806"/>
            <a:ext cx="5517589" cy="371944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0E659C6-6D8D-E634-8118-8150EB5D8E6C}"/>
              </a:ext>
            </a:extLst>
          </p:cNvPr>
          <p:cNvSpPr txBox="1"/>
          <p:nvPr/>
        </p:nvSpPr>
        <p:spPr>
          <a:xfrm>
            <a:off x="262702" y="26393"/>
            <a:ext cx="3996814" cy="3262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2993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85BB90F-C852-6C87-474E-9C3CCC8AA657}"/>
              </a:ext>
            </a:extLst>
          </p:cNvPr>
          <p:cNvSpPr txBox="1"/>
          <p:nvPr/>
        </p:nvSpPr>
        <p:spPr>
          <a:xfrm>
            <a:off x="2802195" y="9493102"/>
            <a:ext cx="3996814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 Supplementary Figure S5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CF4816C-7AA6-7EFD-AA8F-797D422E2589}"/>
              </a:ext>
            </a:extLst>
          </p:cNvPr>
          <p:cNvSpPr txBox="1"/>
          <p:nvPr/>
        </p:nvSpPr>
        <p:spPr>
          <a:xfrm>
            <a:off x="377535" y="627120"/>
            <a:ext cx="6244937" cy="18903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Calibri" panose="020F0502020204030204" pitchFamily="34" charset="0"/>
              </a:rPr>
              <a:t>Supplementary Figure S5: </a:t>
            </a:r>
            <a:r>
              <a:rPr lang="en-AU" sz="1200" b="0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Multivariate Cox regression models incorporating the 26-peptide signature</a:t>
            </a:r>
            <a:endParaRPr lang="en-AU" sz="1200" b="1" dirty="0">
              <a:effectLst/>
              <a:latin typeface="Calibri" panose="020F0502020204030204" pitchFamily="34" charset="0"/>
              <a:ea typeface="DengXian Light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del applied to entire 124 patient cohort with risk score only variable that maintained a statistically significant association with RFS.</a:t>
            </a:r>
          </a:p>
          <a:p>
            <a:pPr>
              <a:lnSpc>
                <a:spcPct val="150000"/>
              </a:lnSpc>
            </a:pP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del applied to adjusted 117 patient cohort with 7 patients treated with Cetuximab and &lt;70Gy radiotherapy removed from R sub-group. Risk score performance remained only variable that maintained a statistically significant association with RFS.</a:t>
            </a:r>
          </a:p>
        </p:txBody>
      </p:sp>
    </p:spTree>
    <p:extLst>
      <p:ext uri="{BB962C8B-B14F-4D97-AF65-F5344CB8AC3E}">
        <p14:creationId xmlns:p14="http://schemas.microsoft.com/office/powerpoint/2010/main" val="3750467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95</TotalTime>
  <Words>110</Words>
  <Application>Microsoft Office PowerPoint</Application>
  <PresentationFormat>A4 Paper (210x297 mm)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R</dc:creator>
  <cp:lastModifiedBy>PhilR</cp:lastModifiedBy>
  <cp:revision>325</cp:revision>
  <dcterms:created xsi:type="dcterms:W3CDTF">2022-08-07T22:18:57Z</dcterms:created>
  <dcterms:modified xsi:type="dcterms:W3CDTF">2025-02-23T23:02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4123633</vt:lpwstr>
  </property>
  <property fmtid="{D5CDD505-2E9C-101B-9397-08002B2CF9AE}" pid="3" name="NXPowerLiteSettings">
    <vt:lpwstr>E9000A40064001</vt:lpwstr>
  </property>
  <property fmtid="{D5CDD505-2E9C-101B-9397-08002B2CF9AE}" pid="4" name="NXPowerLiteVersion">
    <vt:lpwstr>D9.1.2</vt:lpwstr>
  </property>
</Properties>
</file>